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464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3A72D5-A584-7110-61C0-7706DB69CA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E2513B5-3027-07F6-8923-899D3DE0E7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D435B5-86BA-4BFF-A8E2-CEFC2E386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08F63B-9F1B-D918-5DCB-036BFDA95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64F1F2-DBA6-3A52-6496-B5A9E932F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368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03C1DC-DAB4-BD3F-A2C7-18758A5498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A0AA4D1-DE38-5F42-4E98-DBFD351FD3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428CF5-8CB5-A6EA-D46B-8F6D9EA87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0A44B0-7DF9-FCE5-86B5-2A24EEC21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8ADF1C-3980-FD12-4EE7-F43690538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474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D50C2A6-3366-EE72-659D-C97F83AD33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D257438-A492-F598-1049-1EC031FE09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5A9DD3-3235-89BB-D50F-BC05B5390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493136-E013-CBC7-332A-EE6D9A33C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B079FE-169B-C5DA-83FE-DDF7F94DA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1970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85C789-E8BB-CE2B-E40D-AAE5C1BD0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C1E474-ECB6-6047-F531-ABB029AD2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6CDA91-416C-2A35-9262-57C608584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7A74BF-6D73-7910-CE16-937FDE148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F2CC4F-3955-7AC8-C2F0-263D0EFFD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606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D80F9F-B4E1-3A08-10DD-30E616789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B6E8BBC-BBBD-CE58-23AF-70E36B83B9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A80BFE-D00A-285F-C935-C3B2A2BAA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83F17D-B9F8-9BEF-4AE2-6F0FD2C9B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19BCDF-A73D-EB7D-6C40-64B01E1AC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008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42666E-A6FA-C933-12C3-0A3E549D78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5C2F15-B77C-E7FF-6BFE-F17DB862E4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48083C2-86C3-8847-43C4-6E060C0435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031946-4D7F-B69A-112F-489878914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4E501B8-739D-3E00-24BF-7515A4A86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F3F71EE-B62B-1404-1E87-5C8A0100A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430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34A1EA-1D17-AD5E-FEE7-9E1C7BCBF0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772A37-EB7F-9952-9FD2-0F3A5E55AB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90C8DCD-9D2F-FA39-0E0A-CD8954BB61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64D8E35-8A59-9FB9-0CD9-232A68F045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E03CA49-6E0C-27A2-F80C-FCBCF47704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9D95D08-BADD-D4FF-3CFD-F3EB77E2C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E9E9FA3-396F-B10A-A647-5272AFD30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D6D1554-B0CA-8048-169F-1662F0420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598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F0E7E1-A168-45F3-DEE9-09152B2E35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749D85E-E2C4-10FD-F892-E13FFC1F3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61749E2-E98C-F0CB-7681-803BBBFFB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28CED34-7A47-A6BA-A086-F0F7CF300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2209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179FED8-29BC-1E1C-A6FC-BE2EF021D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8751DDC-C5C8-738C-A4C0-3D57B07CB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0C2A081-FB2F-77B5-89FD-54B3177A2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0712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6E91F9-66F5-9F49-449B-EAA0A8703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7374AC-1C88-ED39-87A6-25A4A70268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C4C0CAC-EFAE-3616-0262-0634D359EB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DD3CA52-BA47-F5D7-8660-4F1D78B1F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CFF3AA2-8E4A-3789-3BED-ED5A06283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0FF531D-13BF-AB1B-DB14-C7AE554A9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7401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3C676C-EEDC-F917-590E-1DA25C402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BAEEF8D-35E4-9377-E8EE-AB4C89D468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A7ECBD1-1F9D-E3A6-AD55-B12FB4A82F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557173-42A6-77B4-7650-A71CD1ABD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6C5C6A8-3E87-E223-11C5-0643A18B3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48163C-A7B9-6F3C-72C6-FA4A42981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10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A7A6754-7830-FA97-038F-08535BFD4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3C4423E-16F8-11F2-2F58-A93472BF6E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3FD7F0-89E0-B0B9-91BB-686F5B050D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49C5F-6F25-4FE3-821E-2B4C641C08E0}" type="datetimeFigureOut">
              <a:rPr kumimoji="1" lang="ja-JP" altLang="en-US" smtClean="0"/>
              <a:t>2025/7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01EA28-4B28-08A2-DEEA-17A9FA8206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E52B2A-11C1-DB4A-44A3-1AD21D6F7C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5C1D5-2C58-4B90-8933-52BDFFA8B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CCA4D9C-4E72-D891-1570-98E6C604A4A9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ftr"/>
              </p:ext>
            </p:extLst>
          </p:nvPr>
        </p:nvSpPr>
        <p:spPr>
          <a:xfrm>
            <a:off x="63500" y="6642100"/>
            <a:ext cx="433388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ja-JP" altLang="en-US" sz="1000">
                <a:solidFill>
                  <a:srgbClr val="3171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</a:t>
            </a:r>
          </a:p>
        </p:txBody>
      </p:sp>
    </p:spTree>
    <p:extLst>
      <p:ext uri="{BB962C8B-B14F-4D97-AF65-F5344CB8AC3E}">
        <p14:creationId xmlns:p14="http://schemas.microsoft.com/office/powerpoint/2010/main" val="1115011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3E34E59F-6E76-FACB-2673-2E30F2E385D0}"/>
              </a:ext>
            </a:extLst>
          </p:cNvPr>
          <p:cNvGrpSpPr/>
          <p:nvPr/>
        </p:nvGrpSpPr>
        <p:grpSpPr>
          <a:xfrm>
            <a:off x="2518971" y="1196041"/>
            <a:ext cx="6785646" cy="3175000"/>
            <a:chOff x="2429324" y="3683001"/>
            <a:chExt cx="6785646" cy="3175000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83293156-05BA-10CC-9BDF-EA2CCB7AE8E3}"/>
                </a:ext>
              </a:extLst>
            </p:cNvPr>
            <p:cNvGrpSpPr/>
            <p:nvPr/>
          </p:nvGrpSpPr>
          <p:grpSpPr>
            <a:xfrm>
              <a:off x="2429324" y="3683001"/>
              <a:ext cx="6785646" cy="3175000"/>
              <a:chOff x="905324" y="3683000"/>
              <a:chExt cx="6785646" cy="3175000"/>
            </a:xfrm>
          </p:grpSpPr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6CE34375-1DB2-2857-10BC-2D489BF326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06070" y="3683000"/>
                <a:ext cx="6184900" cy="3175000"/>
              </a:xfrm>
              <a:prstGeom prst="rect">
                <a:avLst/>
              </a:prstGeom>
            </p:spPr>
          </p:pic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EA4CA76A-2440-2D00-D9F5-8941D0ECBB11}"/>
                  </a:ext>
                </a:extLst>
              </p:cNvPr>
              <p:cNvSpPr txBox="1"/>
              <p:nvPr/>
            </p:nvSpPr>
            <p:spPr>
              <a:xfrm>
                <a:off x="905324" y="4020518"/>
                <a:ext cx="10005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HP-#207</a:t>
                </a:r>
                <a:endPara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D705A8B3-0665-1042-0ED9-D6F4693AC0A0}"/>
                  </a:ext>
                </a:extLst>
              </p:cNvPr>
              <p:cNvSpPr txBox="1"/>
              <p:nvPr/>
            </p:nvSpPr>
            <p:spPr>
              <a:xfrm>
                <a:off x="1133505" y="3705384"/>
                <a:ext cx="7024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HP-1</a:t>
                </a:r>
                <a:endPara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直線コネクタ 15">
                <a:extLst>
                  <a:ext uri="{FF2B5EF4-FFF2-40B4-BE49-F238E27FC236}">
                    <a16:creationId xmlns:a16="http://schemas.microsoft.com/office/drawing/2014/main" id="{E71D65F8-A71D-3394-84CC-45221C63AE7B}"/>
                  </a:ext>
                </a:extLst>
              </p:cNvPr>
              <p:cNvCxnSpPr/>
              <p:nvPr/>
            </p:nvCxnSpPr>
            <p:spPr>
              <a:xfrm>
                <a:off x="3495416" y="4747813"/>
                <a:ext cx="218975" cy="0"/>
              </a:xfrm>
              <a:prstGeom prst="line">
                <a:avLst/>
              </a:prstGeom>
              <a:ln>
                <a:solidFill>
                  <a:schemeClr val="accent2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コネクタ 16">
                <a:extLst>
                  <a:ext uri="{FF2B5EF4-FFF2-40B4-BE49-F238E27FC236}">
                    <a16:creationId xmlns:a16="http://schemas.microsoft.com/office/drawing/2014/main" id="{12FADA43-D4D4-B0CE-FE9B-C3223A0D81E2}"/>
                  </a:ext>
                </a:extLst>
              </p:cNvPr>
              <p:cNvCxnSpPr/>
              <p:nvPr/>
            </p:nvCxnSpPr>
            <p:spPr>
              <a:xfrm>
                <a:off x="3428065" y="5553073"/>
                <a:ext cx="218975" cy="0"/>
              </a:xfrm>
              <a:prstGeom prst="line">
                <a:avLst/>
              </a:prstGeom>
              <a:ln>
                <a:solidFill>
                  <a:schemeClr val="accent2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610C4E28-85A6-D0BB-B944-126ACB1C33CA}"/>
                </a:ext>
              </a:extLst>
            </p:cNvPr>
            <p:cNvCxnSpPr/>
            <p:nvPr/>
          </p:nvCxnSpPr>
          <p:spPr>
            <a:xfrm flipH="1">
              <a:off x="5238392" y="4747813"/>
              <a:ext cx="1635007" cy="0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CADC22E3-A3C7-62FD-EBE1-5557E770235E}"/>
                </a:ext>
              </a:extLst>
            </p:cNvPr>
            <p:cNvCxnSpPr/>
            <p:nvPr/>
          </p:nvCxnSpPr>
          <p:spPr>
            <a:xfrm>
              <a:off x="8244402" y="4746337"/>
              <a:ext cx="36000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9FE17809-4CCA-70DA-8C28-F8C30A1AF4E7}"/>
                </a:ext>
              </a:extLst>
            </p:cNvPr>
            <p:cNvCxnSpPr/>
            <p:nvPr/>
          </p:nvCxnSpPr>
          <p:spPr>
            <a:xfrm>
              <a:off x="3601801" y="5568738"/>
              <a:ext cx="1368000" cy="0"/>
            </a:xfrm>
            <a:prstGeom prst="straightConnector1">
              <a:avLst/>
            </a:prstGeom>
            <a:ln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52880964-DB4B-4F1F-4D73-4B1621AEFEE7}"/>
                </a:ext>
              </a:extLst>
            </p:cNvPr>
            <p:cNvSpPr txBox="1"/>
            <p:nvPr/>
          </p:nvSpPr>
          <p:spPr>
            <a:xfrm>
              <a:off x="4969802" y="4355191"/>
              <a:ext cx="4729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Noteworthy Light"/>
                  <a:cs typeface="Noteworthy Light"/>
                </a:rPr>
                <a:t>PAM</a:t>
              </a:r>
              <a:endParaRPr lang="ja-JP" altLang="en-US" sz="1100" dirty="0">
                <a:solidFill>
                  <a:srgbClr val="FF0000"/>
                </a:solidFill>
                <a:latin typeface="Noteworthy Light"/>
                <a:cs typeface="Noteworthy Light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5FE93AB-020A-81DD-BA3F-6C7DA8CE4A35}"/>
                </a:ext>
              </a:extLst>
            </p:cNvPr>
            <p:cNvSpPr txBox="1"/>
            <p:nvPr/>
          </p:nvSpPr>
          <p:spPr>
            <a:xfrm>
              <a:off x="5595165" y="4355191"/>
              <a:ext cx="6751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err="1">
                  <a:solidFill>
                    <a:schemeClr val="tx2">
                      <a:lumMod val="60000"/>
                      <a:lumOff val="40000"/>
                    </a:schemeClr>
                  </a:solidFill>
                  <a:latin typeface="Noteworthy Light"/>
                  <a:cs typeface="Noteworthy Light"/>
                </a:rPr>
                <a:t>sgRNA</a:t>
              </a:r>
              <a:r>
                <a:rPr lang="en-US" altLang="ja-JP" sz="1100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Noteworthy Light"/>
                  <a:cs typeface="Noteworthy Light"/>
                </a:rPr>
                <a:t>-R</a:t>
              </a:r>
              <a:endParaRPr lang="ja-JP" altLang="en-US" sz="1100" dirty="0">
                <a:solidFill>
                  <a:schemeClr val="tx2">
                    <a:lumMod val="60000"/>
                    <a:lumOff val="40000"/>
                  </a:schemeClr>
                </a:solidFill>
                <a:latin typeface="Noteworthy Light"/>
                <a:cs typeface="Noteworthy Light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21354759-3002-CA31-EFCD-857163304871}"/>
                </a:ext>
              </a:extLst>
            </p:cNvPr>
            <p:cNvSpPr txBox="1"/>
            <p:nvPr/>
          </p:nvSpPr>
          <p:spPr>
            <a:xfrm>
              <a:off x="4133281" y="5185507"/>
              <a:ext cx="6623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err="1">
                  <a:solidFill>
                    <a:schemeClr val="tx2">
                      <a:lumMod val="60000"/>
                      <a:lumOff val="40000"/>
                    </a:schemeClr>
                  </a:solidFill>
                  <a:latin typeface="Noteworthy Light"/>
                  <a:cs typeface="Noteworthy Light"/>
                </a:rPr>
                <a:t>sgRNA</a:t>
              </a:r>
              <a:r>
                <a:rPr lang="en-US" altLang="ja-JP" sz="1100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Noteworthy Light"/>
                  <a:cs typeface="Noteworthy Light"/>
                </a:rPr>
                <a:t>-F</a:t>
              </a:r>
              <a:endParaRPr lang="ja-JP" altLang="en-US" sz="1100" dirty="0">
                <a:solidFill>
                  <a:schemeClr val="tx2">
                    <a:lumMod val="60000"/>
                    <a:lumOff val="40000"/>
                  </a:schemeClr>
                </a:solidFill>
                <a:latin typeface="Noteworthy Light"/>
                <a:cs typeface="Noteworthy Light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1BCB33A-B56C-D4D2-402B-A583B7D6768E}"/>
                </a:ext>
              </a:extLst>
            </p:cNvPr>
            <p:cNvSpPr txBox="1"/>
            <p:nvPr/>
          </p:nvSpPr>
          <p:spPr>
            <a:xfrm>
              <a:off x="4825071" y="5182246"/>
              <a:ext cx="4729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solidFill>
                    <a:srgbClr val="FF0000"/>
                  </a:solidFill>
                  <a:latin typeface="Noteworthy Light"/>
                  <a:cs typeface="Noteworthy Light"/>
                </a:rPr>
                <a:t>PAM</a:t>
              </a:r>
              <a:endParaRPr lang="ja-JP" altLang="en-US" sz="1100" dirty="0">
                <a:solidFill>
                  <a:srgbClr val="FF0000"/>
                </a:solidFill>
                <a:latin typeface="Noteworthy Light"/>
                <a:cs typeface="Noteworthy Light"/>
              </a:endParaRPr>
            </a:p>
          </p:txBody>
        </p: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6F8FDEF-A4E4-2218-244E-781C2D9AC90B}"/>
              </a:ext>
            </a:extLst>
          </p:cNvPr>
          <p:cNvSpPr txBox="1"/>
          <p:nvPr/>
        </p:nvSpPr>
        <p:spPr>
          <a:xfrm>
            <a:off x="2832847" y="4724400"/>
            <a:ext cx="631115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Palatino Linotype" panose="02040502050505030304" pitchFamily="18" charset="0"/>
              </a:rPr>
              <a:t>Figure S1 </a:t>
            </a:r>
          </a:p>
          <a:p>
            <a:endParaRPr lang="en-US" altLang="ja-JP" sz="16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Palatino Linotype" panose="02040502050505030304" pitchFamily="18" charset="0"/>
                <a:cs typeface="Arial" panose="020B0604020202020204" pitchFamily="34" charset="0"/>
              </a:rPr>
              <a:t>DNA-sequencing of target region. Genomic DNA of cells were PCR-amplified</a:t>
            </a:r>
            <a:r>
              <a:rPr lang="en-US" altLang="ja-JP" sz="1600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kumimoji="1" lang="en-US" altLang="ja-JP" sz="1600" dirty="0">
                <a:latin typeface="Palatino Linotype" panose="02040502050505030304" pitchFamily="18" charset="0"/>
                <a:cs typeface="Arial" panose="020B0604020202020204" pitchFamily="34" charset="0"/>
              </a:rPr>
              <a:t>3bp of PAM was indicated with </a:t>
            </a:r>
            <a:r>
              <a:rPr lang="en-US" altLang="ja-JP" sz="1600" dirty="0">
                <a:latin typeface="Palatino Linotype" panose="02040502050505030304" pitchFamily="18" charset="0"/>
                <a:cs typeface="Arial" panose="020B0604020202020204" pitchFamily="34" charset="0"/>
              </a:rPr>
              <a:t>red underline, and sgRNA with blue underline.</a:t>
            </a:r>
            <a:r>
              <a:rPr kumimoji="1" lang="en-US" altLang="ja-JP" sz="16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kumimoji="1" lang="ja-JP" altLang="en-US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4980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7</Words>
  <Application>Microsoft Macintosh PowerPoint</Application>
  <PresentationFormat>ワイド画面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Noteworthy Light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合津 陽子/ Gozu Yoko</dc:creator>
  <cp:lastModifiedBy>篤人 中尾</cp:lastModifiedBy>
  <cp:revision>2</cp:revision>
  <dcterms:created xsi:type="dcterms:W3CDTF">2025-07-10T05:28:30Z</dcterms:created>
  <dcterms:modified xsi:type="dcterms:W3CDTF">2025-07-13T05:03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900c6f-39e5-434a-b4c3-be3e591a7835_Enabled">
    <vt:lpwstr>true</vt:lpwstr>
  </property>
  <property fmtid="{D5CDD505-2E9C-101B-9397-08002B2CF9AE}" pid="3" name="MSIP_Label_b7900c6f-39e5-434a-b4c3-be3e591a7835_SetDate">
    <vt:lpwstr>2025-07-10T05:28:30Z</vt:lpwstr>
  </property>
  <property fmtid="{D5CDD505-2E9C-101B-9397-08002B2CF9AE}" pid="4" name="MSIP_Label_b7900c6f-39e5-434a-b4c3-be3e591a7835_Method">
    <vt:lpwstr>Standard</vt:lpwstr>
  </property>
  <property fmtid="{D5CDD505-2E9C-101B-9397-08002B2CF9AE}" pid="5" name="MSIP_Label_b7900c6f-39e5-434a-b4c3-be3e591a7835_Name">
    <vt:lpwstr>b7900c6f-39e5-434a-b4c3-be3e591a7835</vt:lpwstr>
  </property>
  <property fmtid="{D5CDD505-2E9C-101B-9397-08002B2CF9AE}" pid="6" name="MSIP_Label_b7900c6f-39e5-434a-b4c3-be3e591a7835_SiteId">
    <vt:lpwstr>602fb212-70b3-4ef8-938e-9ba98c5ab37a</vt:lpwstr>
  </property>
  <property fmtid="{D5CDD505-2E9C-101B-9397-08002B2CF9AE}" pid="7" name="MSIP_Label_b7900c6f-39e5-434a-b4c3-be3e591a7835_ActionId">
    <vt:lpwstr>34d3d48b-98fa-49f7-8bd9-f77457f82c7a</vt:lpwstr>
  </property>
  <property fmtid="{D5CDD505-2E9C-101B-9397-08002B2CF9AE}" pid="8" name="MSIP_Label_b7900c6f-39e5-434a-b4c3-be3e591a7835_ContentBits">
    <vt:lpwstr>2</vt:lpwstr>
  </property>
  <property fmtid="{D5CDD505-2E9C-101B-9397-08002B2CF9AE}" pid="9" name="ClassificationContentMarkingFooterLocations">
    <vt:lpwstr>Office テーマ:8</vt:lpwstr>
  </property>
  <property fmtid="{D5CDD505-2E9C-101B-9397-08002B2CF9AE}" pid="10" name="ClassificationContentMarkingFooterText">
    <vt:lpwstr>Internal</vt:lpwstr>
  </property>
</Properties>
</file>